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6D6C29F-00D0-B000-F78E-A26F2641047A}" v="6" dt="2021-04-29T01:33:09.95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1" autoAdjust="0"/>
    <p:restoredTop sz="94660"/>
  </p:normalViewPr>
  <p:slideViewPr>
    <p:cSldViewPr snapToGrid="0">
      <p:cViewPr varScale="1">
        <p:scale>
          <a:sx n="121" d="100"/>
          <a:sy n="121" d="100"/>
        </p:scale>
        <p:origin x="96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athryn M Guthridge (DJPR)" userId="S::kathryn.guthridge@agriculture.vic.gov.au::985e3336-125c-464e-a99e-9bd7c6ecab71" providerId="AD" clId="Web-{E6D6C29F-00D0-B000-F78E-A26F2641047A}"/>
    <pc:docChg chg="modSld">
      <pc:chgData name="Kathryn M Guthridge (DJPR)" userId="S::kathryn.guthridge@agriculture.vic.gov.au::985e3336-125c-464e-a99e-9bd7c6ecab71" providerId="AD" clId="Web-{E6D6C29F-00D0-B000-F78E-A26F2641047A}" dt="2021-04-29T01:33:09.954" v="2" actId="20577"/>
      <pc:docMkLst>
        <pc:docMk/>
      </pc:docMkLst>
      <pc:sldChg chg="modSp">
        <pc:chgData name="Kathryn M Guthridge (DJPR)" userId="S::kathryn.guthridge@agriculture.vic.gov.au::985e3336-125c-464e-a99e-9bd7c6ecab71" providerId="AD" clId="Web-{E6D6C29F-00D0-B000-F78E-A26F2641047A}" dt="2021-04-29T01:33:09.954" v="2" actId="20577"/>
        <pc:sldMkLst>
          <pc:docMk/>
          <pc:sldMk cId="882537042" sldId="256"/>
        </pc:sldMkLst>
        <pc:spChg chg="mod">
          <ac:chgData name="Kathryn M Guthridge (DJPR)" userId="S::kathryn.guthridge@agriculture.vic.gov.au::985e3336-125c-464e-a99e-9bd7c6ecab71" providerId="AD" clId="Web-{E6D6C29F-00D0-B000-F78E-A26F2641047A}" dt="2021-04-29T01:33:09.954" v="2" actId="20577"/>
          <ac:spMkLst>
            <pc:docMk/>
            <pc:sldMk cId="882537042" sldId="256"/>
            <ac:spMk id="3" creationId="{B1BE51F1-7FED-45CF-BB2F-83FAD6FCB9D8}"/>
          </ac:spMkLst>
        </pc:spChg>
      </pc:sldChg>
    </pc:docChg>
  </pc:docChgLst>
  <pc:docChgLst>
    <pc:chgData name="Kathryn M Guthridge (DJPR)" userId="S::kathryn.guthridge@agriculture.vic.gov.au::985e3336-125c-464e-a99e-9bd7c6ecab71" providerId="AD" clId="Web-{AB48F5E1-97A3-B362-5ADD-9CA8C7FF065E}"/>
    <pc:docChg chg="modSld">
      <pc:chgData name="Kathryn M Guthridge (DJPR)" userId="S::kathryn.guthridge@agriculture.vic.gov.au::985e3336-125c-464e-a99e-9bd7c6ecab71" providerId="AD" clId="Web-{AB48F5E1-97A3-B362-5ADD-9CA8C7FF065E}" dt="2021-03-29T01:27:34.041" v="0" actId="1076"/>
      <pc:docMkLst>
        <pc:docMk/>
      </pc:docMkLst>
      <pc:sldChg chg="modSp">
        <pc:chgData name="Kathryn M Guthridge (DJPR)" userId="S::kathryn.guthridge@agriculture.vic.gov.au::985e3336-125c-464e-a99e-9bd7c6ecab71" providerId="AD" clId="Web-{AB48F5E1-97A3-B362-5ADD-9CA8C7FF065E}" dt="2021-03-29T01:27:34.041" v="0" actId="1076"/>
        <pc:sldMkLst>
          <pc:docMk/>
          <pc:sldMk cId="882537042" sldId="256"/>
        </pc:sldMkLst>
        <pc:spChg chg="mod">
          <ac:chgData name="Kathryn M Guthridge (DJPR)" userId="S::kathryn.guthridge@agriculture.vic.gov.au::985e3336-125c-464e-a99e-9bd7c6ecab71" providerId="AD" clId="Web-{AB48F5E1-97A3-B362-5ADD-9CA8C7FF065E}" dt="2021-03-29T01:27:34.041" v="0" actId="1076"/>
          <ac:spMkLst>
            <pc:docMk/>
            <pc:sldMk cId="882537042" sldId="256"/>
            <ac:spMk id="3" creationId="{B1BE51F1-7FED-45CF-BB2F-83FAD6FCB9D8}"/>
          </ac:spMkLst>
        </pc:spChg>
      </pc:sldChg>
    </pc:docChg>
  </pc:docChgLst>
  <pc:docChgLst>
    <pc:chgData name="Inoka Hettiarachchige (DJPR)" userId="72e268ac-d0c6-4335-bfc6-e8215c497fdd" providerId="ADAL" clId="{B003B790-43A8-4BFF-8F61-B73264DC9EDA}"/>
    <pc:docChg chg="modSld">
      <pc:chgData name="Inoka Hettiarachchige (DJPR)" userId="72e268ac-d0c6-4335-bfc6-e8215c497fdd" providerId="ADAL" clId="{B003B790-43A8-4BFF-8F61-B73264DC9EDA}" dt="2021-03-31T22:33:55.506" v="3" actId="1076"/>
      <pc:docMkLst>
        <pc:docMk/>
      </pc:docMkLst>
      <pc:sldChg chg="modSp mod">
        <pc:chgData name="Inoka Hettiarachchige (DJPR)" userId="72e268ac-d0c6-4335-bfc6-e8215c497fdd" providerId="ADAL" clId="{B003B790-43A8-4BFF-8F61-B73264DC9EDA}" dt="2021-03-31T22:33:55.506" v="3" actId="1076"/>
        <pc:sldMkLst>
          <pc:docMk/>
          <pc:sldMk cId="882537042" sldId="256"/>
        </pc:sldMkLst>
        <pc:spChg chg="mod">
          <ac:chgData name="Inoka Hettiarachchige (DJPR)" userId="72e268ac-d0c6-4335-bfc6-e8215c497fdd" providerId="ADAL" clId="{B003B790-43A8-4BFF-8F61-B73264DC9EDA}" dt="2021-03-31T22:33:55.506" v="3" actId="1076"/>
          <ac:spMkLst>
            <pc:docMk/>
            <pc:sldMk cId="882537042" sldId="256"/>
            <ac:spMk id="3" creationId="{B1BE51F1-7FED-45CF-BB2F-83FAD6FCB9D8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FDDD74-8F99-4E68-919A-6C26CF406E5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7FB9238-900A-4541-9946-19E28D2A678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E554D2-525E-4DEC-9BC1-39A20516A2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69727-B10D-459E-AF38-81DFB164AE77}" type="datetimeFigureOut">
              <a:rPr lang="en-AU" smtClean="0"/>
              <a:t>28/04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CFEC71-77EF-49B7-9577-3D87AC4063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7117C7-C3AD-4585-81BC-79CDCF2AA9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B9148-BED1-4DB1-8620-941C111E17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103818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04E6A4-E1EF-44E4-B476-90E0D526C6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BF02D0B-32A8-4606-82B8-5C308B91A43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F47BE3-1B60-4876-9ADA-0562AF207A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69727-B10D-459E-AF38-81DFB164AE77}" type="datetimeFigureOut">
              <a:rPr lang="en-AU" smtClean="0"/>
              <a:t>28/04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CEE00A-FD24-4FBC-905E-379E080B46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5BC638-A0DB-4BB2-9F1C-A9812F92E7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B9148-BED1-4DB1-8620-941C111E17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084564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BC1C684-978C-4EEB-8FEF-86019A13481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394DA98-0234-4807-8C13-55B407AABE5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EA2CD0-3FA7-4386-9E03-A58CE2F5E9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69727-B10D-459E-AF38-81DFB164AE77}" type="datetimeFigureOut">
              <a:rPr lang="en-AU" smtClean="0"/>
              <a:t>28/04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2F3C27-8B53-447D-9602-F87D758752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25E48D-FE2D-4D2E-A12A-84E47BFC35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B9148-BED1-4DB1-8620-941C111E17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266893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15FBD0-0303-43A4-BB51-9393491735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646122-E67F-49EA-9B2A-04805F9CBD3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DDC0CD-B85A-4EC9-B958-F5DA8F7283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69727-B10D-459E-AF38-81DFB164AE77}" type="datetimeFigureOut">
              <a:rPr lang="en-AU" smtClean="0"/>
              <a:t>28/04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E928E0-7D0A-49D5-8BB3-AC3183D96A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791B31-DAC2-42F8-A4A1-7330F903CC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B9148-BED1-4DB1-8620-941C111E17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732811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B76FCF-ED7A-4ED3-8FDA-E2741A850F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AAD327B-19D9-4C73-8FAE-6BC9E0F6EA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7658F3-C6F3-42B3-A9BB-37413CFE5F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69727-B10D-459E-AF38-81DFB164AE77}" type="datetimeFigureOut">
              <a:rPr lang="en-AU" smtClean="0"/>
              <a:t>28/04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1F9630-78E3-4190-B02E-323B578FEE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E2FE0F-6096-4170-9965-0F2123F0DE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B9148-BED1-4DB1-8620-941C111E17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345537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8D8C39-4B6A-467B-A085-53085CF5D4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9BF809A-3A98-40A8-B4DE-E07F7AB6DF2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795C88C-9729-4CC0-9691-B1E6FE68CB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4C298D-F23B-432D-90A8-74D16B4C57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69727-B10D-459E-AF38-81DFB164AE77}" type="datetimeFigureOut">
              <a:rPr lang="en-AU" smtClean="0"/>
              <a:t>28/04/2021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1843D86-57F8-4CDF-9E25-CCD4A6130E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7C70CA8-DF51-4D35-8DDE-AE164AA4A8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B9148-BED1-4DB1-8620-941C111E17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800626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081647-549E-40F7-91CF-72DBC2D7B0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F511B4-D1CF-45D7-B3B6-F877FCB64A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84BF9DE-FB09-40CF-B8BD-13C1DAA92F4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BE066D7-B7F2-424C-8EEA-ECF6D460DD8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FB49E79-A776-4084-A885-01EF70E97C0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E3FD880-6F5B-4CF2-B2F2-D32271C2BF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69727-B10D-459E-AF38-81DFB164AE77}" type="datetimeFigureOut">
              <a:rPr lang="en-AU" smtClean="0"/>
              <a:t>28/04/2021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9D3EF9E-29CD-425B-A4B0-47D3ED814B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60F068A-BF00-4FB4-BD76-40679FC73E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B9148-BED1-4DB1-8620-941C111E17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28957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099E59-4E44-40AC-A3D6-117A156D26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F9E4C84-FA44-45D4-BD32-310F98A30A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69727-B10D-459E-AF38-81DFB164AE77}" type="datetimeFigureOut">
              <a:rPr lang="en-AU" smtClean="0"/>
              <a:t>28/04/2021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5A5DDE8-1DA5-469D-8E2D-B2FA948258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85C6C1B-DCE8-4FA3-99A0-1A985E8126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B9148-BED1-4DB1-8620-941C111E17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353728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CC436A7-D5E6-42FC-9AFD-5B447EC705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69727-B10D-459E-AF38-81DFB164AE77}" type="datetimeFigureOut">
              <a:rPr lang="en-AU" smtClean="0"/>
              <a:t>28/04/2021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947C437-CD62-4885-B13C-B535FD023E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FE3DF4D-521E-4B3A-B731-995786A5A0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B9148-BED1-4DB1-8620-941C111E17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989387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39FBEC-36F8-4F41-9BE7-37B2D5DFCE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A5C8CE-946C-4489-A1C1-F5150C9B40E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98ADC71-954E-492B-A2F0-340A1F0D57E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1E47F6-AFD6-438D-914A-24ACA77DB2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69727-B10D-459E-AF38-81DFB164AE77}" type="datetimeFigureOut">
              <a:rPr lang="en-AU" smtClean="0"/>
              <a:t>28/04/2021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E886586-D1DF-4E2F-95AA-66EDE6D5B0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A9542F4-8B67-44D9-9119-4CB64B2BB7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B9148-BED1-4DB1-8620-941C111E17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359721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7E0FAA-2AA4-49DB-8DD4-31479D551F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4E39475-FFCC-4756-A4C4-926D24157A3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CA08470-D608-46C3-B0E5-4157417CB0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CC01E2B-317A-4B24-8407-8018CF3F7A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69727-B10D-459E-AF38-81DFB164AE77}" type="datetimeFigureOut">
              <a:rPr lang="en-AU" smtClean="0"/>
              <a:t>28/04/2021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7FC8F82-A727-4CA4-AED1-6BC8221CDB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AE44D07-B6BF-4020-9BA9-E54ABDB2B5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B9148-BED1-4DB1-8620-941C111E17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403962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A009001-0545-4802-A999-41BA66737B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C2982FA-5EF9-4F1A-AAD8-DEC0D13AC8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F282A4-5086-4D67-B43C-54DE077E635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369727-B10D-459E-AF38-81DFB164AE77}" type="datetimeFigureOut">
              <a:rPr lang="en-AU" smtClean="0"/>
              <a:t>28/04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4B89B1-6D00-41AB-AD49-4953762A60C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CCA651-0B21-4592-A871-93AB2856978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DB9148-BED1-4DB1-8620-941C111E17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324911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A screenshot of a cell phone&#10;&#10;Description automatically generated">
            <a:extLst>
              <a:ext uri="{FF2B5EF4-FFF2-40B4-BE49-F238E27FC236}">
                <a16:creationId xmlns:a16="http://schemas.microsoft.com/office/drawing/2014/main" id="{52A1C025-F148-4114-9E7B-3AAC2A54A6A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870"/>
          <a:stretch/>
        </p:blipFill>
        <p:spPr>
          <a:xfrm>
            <a:off x="8166838" y="571026"/>
            <a:ext cx="4068000" cy="2965492"/>
          </a:xfrm>
          <a:prstGeom prst="rect">
            <a:avLst/>
          </a:prstGeom>
        </p:spPr>
      </p:pic>
      <p:pic>
        <p:nvPicPr>
          <p:cNvPr id="6" name="Picture 5" descr="A close up of text on a white background&#10;&#10;Description automatically generated">
            <a:extLst>
              <a:ext uri="{FF2B5EF4-FFF2-40B4-BE49-F238E27FC236}">
                <a16:creationId xmlns:a16="http://schemas.microsoft.com/office/drawing/2014/main" id="{9DC2BE8B-F163-48D0-B076-B988001CCAF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400"/>
          <a:stretch/>
        </p:blipFill>
        <p:spPr>
          <a:xfrm>
            <a:off x="4081929" y="571026"/>
            <a:ext cx="4068000" cy="2903040"/>
          </a:xfrm>
          <a:prstGeom prst="rect">
            <a:avLst/>
          </a:prstGeom>
        </p:spPr>
      </p:pic>
      <p:pic>
        <p:nvPicPr>
          <p:cNvPr id="12" name="Picture 11" descr="A screenshot of a cell phone&#10;&#10;Description automatically generated">
            <a:extLst>
              <a:ext uri="{FF2B5EF4-FFF2-40B4-BE49-F238E27FC236}">
                <a16:creationId xmlns:a16="http://schemas.microsoft.com/office/drawing/2014/main" id="{33D0D681-1304-4F9B-91F1-2C551E49083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400"/>
          <a:stretch/>
        </p:blipFill>
        <p:spPr>
          <a:xfrm>
            <a:off x="0" y="571026"/>
            <a:ext cx="4068000" cy="290303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CA6118C9-9669-42E5-AF77-3778AC7FF2F9}"/>
              </a:ext>
            </a:extLst>
          </p:cNvPr>
          <p:cNvSpPr txBox="1"/>
          <p:nvPr/>
        </p:nvSpPr>
        <p:spPr>
          <a:xfrm>
            <a:off x="281718" y="263250"/>
            <a:ext cx="3386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>
                <a:latin typeface="Palatino Linotype" panose="02040502050505030304" pitchFamily="18" charset="0"/>
              </a:rPr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1910ACC-C20A-4BAA-926B-C91C088888FD}"/>
              </a:ext>
            </a:extLst>
          </p:cNvPr>
          <p:cNvSpPr txBox="1"/>
          <p:nvPr/>
        </p:nvSpPr>
        <p:spPr>
          <a:xfrm>
            <a:off x="4354701" y="263250"/>
            <a:ext cx="3386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>
                <a:latin typeface="Palatino Linotype" panose="02040502050505030304" pitchFamily="18" charset="0"/>
              </a:rPr>
              <a:t>B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AF1AD9A-10AE-43BD-B760-006BAE4C809E}"/>
              </a:ext>
            </a:extLst>
          </p:cNvPr>
          <p:cNvSpPr txBox="1"/>
          <p:nvPr/>
        </p:nvSpPr>
        <p:spPr>
          <a:xfrm>
            <a:off x="8438888" y="263250"/>
            <a:ext cx="3386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>
                <a:latin typeface="Palatino Linotype" panose="02040502050505030304" pitchFamily="18" charset="0"/>
              </a:rPr>
              <a:t>C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B1BE51F1-7FED-45CF-BB2F-83FAD6FCB9D8}"/>
              </a:ext>
            </a:extLst>
          </p:cNvPr>
          <p:cNvSpPr/>
          <p:nvPr/>
        </p:nvSpPr>
        <p:spPr>
          <a:xfrm>
            <a:off x="434194" y="3635625"/>
            <a:ext cx="11386450" cy="281552"/>
          </a:xfrm>
          <a:prstGeom prst="rect">
            <a:avLst/>
          </a:prstGeom>
        </p:spPr>
        <p:txBody>
          <a:bodyPr wrap="none" lIns="91440" tIns="45720" rIns="91440" bIns="45720" anchor="t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AU" sz="1200" b="1" dirty="0">
                <a:latin typeface="Palatino Linotype"/>
                <a:ea typeface="Calibri" panose="020F0502020204030204" pitchFamily="34" charset="0"/>
                <a:cs typeface="Calibri"/>
              </a:rPr>
              <a:t>Figure S1</a:t>
            </a:r>
            <a:r>
              <a:rPr lang="en-AU" sz="1200">
                <a:latin typeface="Palatino Linotype"/>
                <a:ea typeface="Calibri" panose="020F0502020204030204" pitchFamily="34" charset="0"/>
                <a:cs typeface="Calibri"/>
              </a:rPr>
              <a:t>: MDS plots for the biological replicates of sequencing libraries. (A) SE, (B) NEA11 and (C) NEA12 at 6 different time points of </a:t>
            </a:r>
            <a:r>
              <a:rPr lang="en-AU" sz="1200" dirty="0" err="1">
                <a:latin typeface="Palatino Linotype"/>
                <a:ea typeface="Calibri" panose="020F0502020204030204" pitchFamily="34" charset="0"/>
                <a:cs typeface="Calibri"/>
              </a:rPr>
              <a:t>symbiotum</a:t>
            </a:r>
            <a:r>
              <a:rPr lang="en-AU" sz="1200" dirty="0">
                <a:latin typeface="Palatino Linotype"/>
                <a:ea typeface="Calibri" panose="020F0502020204030204" pitchFamily="34" charset="0"/>
                <a:cs typeface="Calibri"/>
              </a:rPr>
              <a:t> establishment. </a:t>
            </a:r>
            <a:endParaRPr lang="en-AU" sz="1200" dirty="0">
              <a:latin typeface="Palatino Linotype" panose="0204050205050503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825370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78</TotalTime>
  <Words>39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noka Hettiarachchige (DJPR)</dc:creator>
  <cp:lastModifiedBy>Inoka Hettiarachchige (DJPR)</cp:lastModifiedBy>
  <cp:revision>19</cp:revision>
  <dcterms:created xsi:type="dcterms:W3CDTF">2020-05-26T08:30:10Z</dcterms:created>
  <dcterms:modified xsi:type="dcterms:W3CDTF">2021-04-29T01:33:18Z</dcterms:modified>
</cp:coreProperties>
</file>